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31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612" y="102"/>
      </p:cViewPr>
      <p:guideLst>
        <p:guide orient="horz" pos="731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612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153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44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9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9252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622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6583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888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3299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8181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591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D67AC-942D-4FCF-A4C7-C0EE3CB7E7A3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A8A2E-15B3-428D-B082-5856E85AB3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556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Rectangle 56">
            <a:extLst>
              <a:ext uri="{FF2B5EF4-FFF2-40B4-BE49-F238E27FC236}">
                <a16:creationId xmlns:a16="http://schemas.microsoft.com/office/drawing/2014/main" id="{30932778-C8CB-2BF7-BDC7-DD02A227965C}"/>
              </a:ext>
            </a:extLst>
          </p:cNvPr>
          <p:cNvSpPr/>
          <p:nvPr/>
        </p:nvSpPr>
        <p:spPr>
          <a:xfrm>
            <a:off x="8397244" y="2459069"/>
            <a:ext cx="26492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1282699" y="890564"/>
            <a:ext cx="4017433" cy="46944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92996" y="5781270"/>
            <a:ext cx="920600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Figure 1. Technical and biological replicates for in vitro fermentation reactions. </a:t>
            </a:r>
            <a:r>
              <a:rPr lang="en-GB" sz="1100" dirty="0"/>
              <a:t>A) Intra-experimental variability in duplicate fermentation reactions using the same faecal sample for individual participants (P1-P3). Inulin was present at 0.02 mg/ml, The working concentration of mixed omega-3 PUFAs (O3FA) was 50 </a:t>
            </a:r>
            <a:r>
              <a:rPr lang="en-GB" sz="1100" dirty="0">
                <a:latin typeface="Symbol" panose="05050102010706020507" pitchFamily="18" charset="2"/>
              </a:rPr>
              <a:t>m</a:t>
            </a:r>
            <a:r>
              <a:rPr lang="en-GB" sz="1100" dirty="0"/>
              <a:t>g/ml. B) Inter-experimental variability using two different faecal samples one week apart from the same participant (P3). Inulin was present at 0.02 mg/ml, The working concentration of mixed omega-3 PUFAs (O3FA) was 50 </a:t>
            </a:r>
            <a:r>
              <a:rPr lang="en-GB" sz="1100" dirty="0">
                <a:latin typeface="Symbol" panose="05050102010706020507" pitchFamily="18" charset="2"/>
              </a:rPr>
              <a:t>m</a:t>
            </a:r>
            <a:r>
              <a:rPr lang="en-GB" sz="1100" dirty="0"/>
              <a:t>g/ml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63A5DDB-9563-8419-848F-BAA10C4A3C30}"/>
              </a:ext>
            </a:extLst>
          </p:cNvPr>
          <p:cNvGrpSpPr/>
          <p:nvPr/>
        </p:nvGrpSpPr>
        <p:grpSpPr>
          <a:xfrm>
            <a:off x="6619664" y="926352"/>
            <a:ext cx="3413336" cy="3163462"/>
            <a:chOff x="6619664" y="1930400"/>
            <a:chExt cx="3413336" cy="3163462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5860D8E-8F9E-DF40-E47C-D74F68A41B73}"/>
                </a:ext>
              </a:extLst>
            </p:cNvPr>
            <p:cNvGrpSpPr/>
            <p:nvPr/>
          </p:nvGrpSpPr>
          <p:grpSpPr>
            <a:xfrm>
              <a:off x="6619664" y="1930400"/>
              <a:ext cx="3413336" cy="3163462"/>
              <a:chOff x="6619664" y="1930400"/>
              <a:chExt cx="3413336" cy="3163462"/>
            </a:xfrm>
          </p:grpSpPr>
          <p:pic>
            <p:nvPicPr>
              <p:cNvPr id="5" name="Picture 4"/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619664" y="1930400"/>
                <a:ext cx="3413336" cy="3163462"/>
              </a:xfrm>
              <a:prstGeom prst="rect">
                <a:avLst/>
              </a:prstGeom>
            </p:spPr>
          </p:pic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B154F03-DFC3-54E6-C558-EDACE9B12C51}"/>
                  </a:ext>
                </a:extLst>
              </p:cNvPr>
              <p:cNvSpPr/>
              <p:nvPr/>
            </p:nvSpPr>
            <p:spPr>
              <a:xfrm>
                <a:off x="8130988" y="1930400"/>
                <a:ext cx="412377" cy="248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8130402F-20C8-329F-B384-31583DF43076}"/>
                  </a:ext>
                </a:extLst>
              </p:cNvPr>
              <p:cNvSpPr/>
              <p:nvPr/>
            </p:nvSpPr>
            <p:spPr>
              <a:xfrm>
                <a:off x="8059271" y="3429000"/>
                <a:ext cx="573741" cy="33617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ADB028B-A6B8-DC0E-59D4-B6E64EB48D70}"/>
                </a:ext>
              </a:extLst>
            </p:cNvPr>
            <p:cNvSpPr txBox="1"/>
            <p:nvPr/>
          </p:nvSpPr>
          <p:spPr>
            <a:xfrm>
              <a:off x="7978588" y="2023380"/>
              <a:ext cx="7351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ample 1</a:t>
              </a:r>
              <a:endParaRPr lang="en-GB" sz="11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9C34406-0653-8A78-630E-0B32609B5AC2}"/>
                </a:ext>
              </a:extLst>
            </p:cNvPr>
            <p:cNvSpPr txBox="1"/>
            <p:nvPr/>
          </p:nvSpPr>
          <p:spPr>
            <a:xfrm>
              <a:off x="7975720" y="3572904"/>
              <a:ext cx="7351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ample 2</a:t>
              </a:r>
              <a:endParaRPr lang="en-GB" sz="1100" dirty="0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976F9335-9232-A2BF-0732-13CC3694580C}"/>
              </a:ext>
            </a:extLst>
          </p:cNvPr>
          <p:cNvSpPr txBox="1"/>
          <p:nvPr/>
        </p:nvSpPr>
        <p:spPr>
          <a:xfrm>
            <a:off x="851648" y="340659"/>
            <a:ext cx="431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)</a:t>
            </a:r>
            <a:endParaRPr lang="en-GB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8ECBB9-80D3-4FDE-FD28-6E09B0A27E59}"/>
              </a:ext>
            </a:extLst>
          </p:cNvPr>
          <p:cNvSpPr txBox="1"/>
          <p:nvPr/>
        </p:nvSpPr>
        <p:spPr>
          <a:xfrm>
            <a:off x="6284259" y="341747"/>
            <a:ext cx="431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)</a:t>
            </a:r>
            <a:endParaRPr lang="en-GB" b="1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F29635F-AC94-152B-8917-1696A4EA5111}"/>
              </a:ext>
            </a:extLst>
          </p:cNvPr>
          <p:cNvSpPr/>
          <p:nvPr/>
        </p:nvSpPr>
        <p:spPr>
          <a:xfrm>
            <a:off x="3029337" y="819296"/>
            <a:ext cx="26492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D9D1D3-9479-7BCA-DEA4-F8084BBD77B9}"/>
              </a:ext>
            </a:extLst>
          </p:cNvPr>
          <p:cNvSpPr txBox="1"/>
          <p:nvPr/>
        </p:nvSpPr>
        <p:spPr>
          <a:xfrm>
            <a:off x="2990881" y="994960"/>
            <a:ext cx="341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1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F5E7716-939F-9B9E-7590-EC868B4598C6}"/>
              </a:ext>
            </a:extLst>
          </p:cNvPr>
          <p:cNvGrpSpPr/>
          <p:nvPr/>
        </p:nvGrpSpPr>
        <p:grpSpPr>
          <a:xfrm>
            <a:off x="1600199" y="2152260"/>
            <a:ext cx="3704272" cy="516887"/>
            <a:chOff x="1600199" y="2152260"/>
            <a:chExt cx="3704272" cy="516887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FBED7302-0F03-8ED8-B23A-B36982CAD59E}"/>
                </a:ext>
              </a:extLst>
            </p:cNvPr>
            <p:cNvSpPr/>
            <p:nvPr/>
          </p:nvSpPr>
          <p:spPr>
            <a:xfrm>
              <a:off x="1614488" y="2181225"/>
              <a:ext cx="3685644" cy="2263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4EDC307-EAF7-7F21-83C7-CCA53B7416F9}"/>
                </a:ext>
              </a:extLst>
            </p:cNvPr>
            <p:cNvSpPr/>
            <p:nvPr/>
          </p:nvSpPr>
          <p:spPr>
            <a:xfrm>
              <a:off x="3067793" y="2407537"/>
              <a:ext cx="264920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F04A2D2-E15E-A697-7B35-D925F44F2ED0}"/>
                </a:ext>
              </a:extLst>
            </p:cNvPr>
            <p:cNvSpPr txBox="1"/>
            <p:nvPr/>
          </p:nvSpPr>
          <p:spPr>
            <a:xfrm>
              <a:off x="1722155" y="2161870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ontrol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9C2CA8E-FB94-6BFB-0ACE-BF7CEBD1E768}"/>
                </a:ext>
              </a:extLst>
            </p:cNvPr>
            <p:cNvSpPr txBox="1"/>
            <p:nvPr/>
          </p:nvSpPr>
          <p:spPr>
            <a:xfrm>
              <a:off x="3289846" y="2152260"/>
              <a:ext cx="1128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omega-3 PUFA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0955FB8-DD68-1DCF-CA2B-EB52788A3C1C}"/>
                </a:ext>
              </a:extLst>
            </p:cNvPr>
            <p:cNvSpPr txBox="1"/>
            <p:nvPr/>
          </p:nvSpPr>
          <p:spPr>
            <a:xfrm>
              <a:off x="2627031" y="2163707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784BEEB-086E-FC7C-4E3E-37B31737A006}"/>
                </a:ext>
              </a:extLst>
            </p:cNvPr>
            <p:cNvSpPr txBox="1"/>
            <p:nvPr/>
          </p:nvSpPr>
          <p:spPr>
            <a:xfrm>
              <a:off x="4176127" y="2162829"/>
              <a:ext cx="11283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 +</a:t>
              </a:r>
            </a:p>
            <a:p>
              <a:pPr algn="ctr"/>
              <a:r>
                <a:rPr lang="en-GB" sz="1100" dirty="0"/>
                <a:t>omega-3 PUFAs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0C3FE876-6384-E8BC-2592-18311CEE2A21}"/>
                </a:ext>
              </a:extLst>
            </p:cNvPr>
            <p:cNvCxnSpPr>
              <a:cxnSpLocks/>
            </p:cNvCxnSpPr>
            <p:nvPr/>
          </p:nvCxnSpPr>
          <p:spPr>
            <a:xfrm>
              <a:off x="160019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16A3BEAA-4D06-46F2-7851-28430DBB7BDE}"/>
                </a:ext>
              </a:extLst>
            </p:cNvPr>
            <p:cNvCxnSpPr>
              <a:cxnSpLocks/>
            </p:cNvCxnSpPr>
            <p:nvPr/>
          </p:nvCxnSpPr>
          <p:spPr>
            <a:xfrm>
              <a:off x="2505075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AD389CD1-9C0C-5F49-5D85-90D5CB5F4EFF}"/>
                </a:ext>
              </a:extLst>
            </p:cNvPr>
            <p:cNvCxnSpPr>
              <a:cxnSpLocks/>
            </p:cNvCxnSpPr>
            <p:nvPr/>
          </p:nvCxnSpPr>
          <p:spPr>
            <a:xfrm>
              <a:off x="3415868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71EFDAE-C7F2-C69D-4751-2F5398811A8F}"/>
                </a:ext>
              </a:extLst>
            </p:cNvPr>
            <p:cNvCxnSpPr>
              <a:cxnSpLocks/>
            </p:cNvCxnSpPr>
            <p:nvPr/>
          </p:nvCxnSpPr>
          <p:spPr>
            <a:xfrm>
              <a:off x="430214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75589656-B05B-A8AB-302C-7E95E75E1138}"/>
              </a:ext>
            </a:extLst>
          </p:cNvPr>
          <p:cNvGrpSpPr/>
          <p:nvPr/>
        </p:nvGrpSpPr>
        <p:grpSpPr>
          <a:xfrm>
            <a:off x="1605174" y="3712406"/>
            <a:ext cx="3704272" cy="516887"/>
            <a:chOff x="1600199" y="2152260"/>
            <a:chExt cx="3704272" cy="516887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6F11BDA5-26B8-6302-0CFE-AB8B7C568250}"/>
                </a:ext>
              </a:extLst>
            </p:cNvPr>
            <p:cNvSpPr/>
            <p:nvPr/>
          </p:nvSpPr>
          <p:spPr>
            <a:xfrm>
              <a:off x="1614488" y="2181225"/>
              <a:ext cx="3685644" cy="2263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2B7ECAF-8216-9CC8-99B6-EC589C7C23CF}"/>
                </a:ext>
              </a:extLst>
            </p:cNvPr>
            <p:cNvSpPr/>
            <p:nvPr/>
          </p:nvSpPr>
          <p:spPr>
            <a:xfrm>
              <a:off x="3067793" y="2407537"/>
              <a:ext cx="264920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6C6B4E1-2EE3-AA72-34C7-D8996794934C}"/>
                </a:ext>
              </a:extLst>
            </p:cNvPr>
            <p:cNvSpPr txBox="1"/>
            <p:nvPr/>
          </p:nvSpPr>
          <p:spPr>
            <a:xfrm>
              <a:off x="1722155" y="2161870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ontrol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E285939-22FD-3F9A-D1D1-3E592D9BDEBA}"/>
                </a:ext>
              </a:extLst>
            </p:cNvPr>
            <p:cNvSpPr txBox="1"/>
            <p:nvPr/>
          </p:nvSpPr>
          <p:spPr>
            <a:xfrm>
              <a:off x="3289846" y="2152260"/>
              <a:ext cx="1128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omega-3 PUFAs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4840C5F-8DE3-D399-3B49-DD461B5AD3FC}"/>
                </a:ext>
              </a:extLst>
            </p:cNvPr>
            <p:cNvSpPr txBox="1"/>
            <p:nvPr/>
          </p:nvSpPr>
          <p:spPr>
            <a:xfrm>
              <a:off x="2627031" y="2163707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29F7190-E673-22E6-C2FE-B242CF39811A}"/>
                </a:ext>
              </a:extLst>
            </p:cNvPr>
            <p:cNvSpPr txBox="1"/>
            <p:nvPr/>
          </p:nvSpPr>
          <p:spPr>
            <a:xfrm>
              <a:off x="4176127" y="2162829"/>
              <a:ext cx="11283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 +</a:t>
              </a:r>
            </a:p>
            <a:p>
              <a:pPr algn="ctr"/>
              <a:r>
                <a:rPr lang="en-GB" sz="1100" dirty="0"/>
                <a:t>omega-3 PUFAs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C4BA185D-9758-D688-7B6E-6506AD588092}"/>
                </a:ext>
              </a:extLst>
            </p:cNvPr>
            <p:cNvCxnSpPr>
              <a:cxnSpLocks/>
            </p:cNvCxnSpPr>
            <p:nvPr/>
          </p:nvCxnSpPr>
          <p:spPr>
            <a:xfrm>
              <a:off x="160019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294CB02F-1968-6AB0-4F5A-3941B7A9677B}"/>
                </a:ext>
              </a:extLst>
            </p:cNvPr>
            <p:cNvCxnSpPr>
              <a:cxnSpLocks/>
            </p:cNvCxnSpPr>
            <p:nvPr/>
          </p:nvCxnSpPr>
          <p:spPr>
            <a:xfrm>
              <a:off x="2505075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7A314A5-D802-D42E-84FF-D67FC82A0580}"/>
                </a:ext>
              </a:extLst>
            </p:cNvPr>
            <p:cNvCxnSpPr>
              <a:cxnSpLocks/>
            </p:cNvCxnSpPr>
            <p:nvPr/>
          </p:nvCxnSpPr>
          <p:spPr>
            <a:xfrm>
              <a:off x="3415868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3E26220-C3AC-9822-AD41-F57BC1431275}"/>
                </a:ext>
              </a:extLst>
            </p:cNvPr>
            <p:cNvCxnSpPr>
              <a:cxnSpLocks/>
            </p:cNvCxnSpPr>
            <p:nvPr/>
          </p:nvCxnSpPr>
          <p:spPr>
            <a:xfrm>
              <a:off x="430214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BBFE91FD-2584-F4D2-2AEA-4E3C07F34894}"/>
              </a:ext>
            </a:extLst>
          </p:cNvPr>
          <p:cNvGrpSpPr/>
          <p:nvPr/>
        </p:nvGrpSpPr>
        <p:grpSpPr>
          <a:xfrm>
            <a:off x="1595860" y="5272712"/>
            <a:ext cx="3704272" cy="516887"/>
            <a:chOff x="1600199" y="2152260"/>
            <a:chExt cx="3704272" cy="516887"/>
          </a:xfrm>
        </p:grpSpPr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A7FC9B1E-F077-4133-6AB6-22194DEA2799}"/>
                </a:ext>
              </a:extLst>
            </p:cNvPr>
            <p:cNvSpPr/>
            <p:nvPr/>
          </p:nvSpPr>
          <p:spPr>
            <a:xfrm>
              <a:off x="1614488" y="2181225"/>
              <a:ext cx="3685644" cy="2263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D58E3359-4743-C32E-59A9-02BB2ADC2A7A}"/>
                </a:ext>
              </a:extLst>
            </p:cNvPr>
            <p:cNvSpPr/>
            <p:nvPr/>
          </p:nvSpPr>
          <p:spPr>
            <a:xfrm>
              <a:off x="3067793" y="2407537"/>
              <a:ext cx="264920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1BE10CB-A2B0-8C85-08F3-EEC7CC155EB7}"/>
                </a:ext>
              </a:extLst>
            </p:cNvPr>
            <p:cNvSpPr txBox="1"/>
            <p:nvPr/>
          </p:nvSpPr>
          <p:spPr>
            <a:xfrm>
              <a:off x="1722155" y="2161870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ontrol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D7DBFEB-1FAF-0053-C5D5-A7FC8A564534}"/>
                </a:ext>
              </a:extLst>
            </p:cNvPr>
            <p:cNvSpPr txBox="1"/>
            <p:nvPr/>
          </p:nvSpPr>
          <p:spPr>
            <a:xfrm>
              <a:off x="3289846" y="2152260"/>
              <a:ext cx="1128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omega-3 PUFAs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89DBABE-0CB6-F9BF-EA0F-291D65C9ED89}"/>
                </a:ext>
              </a:extLst>
            </p:cNvPr>
            <p:cNvSpPr txBox="1"/>
            <p:nvPr/>
          </p:nvSpPr>
          <p:spPr>
            <a:xfrm>
              <a:off x="2627031" y="2163707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EC2A445-E3B6-B1EF-1FAA-723BEC0DFD1D}"/>
                </a:ext>
              </a:extLst>
            </p:cNvPr>
            <p:cNvSpPr txBox="1"/>
            <p:nvPr/>
          </p:nvSpPr>
          <p:spPr>
            <a:xfrm>
              <a:off x="4176127" y="2162829"/>
              <a:ext cx="11283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 +</a:t>
              </a:r>
            </a:p>
            <a:p>
              <a:pPr algn="ctr"/>
              <a:r>
                <a:rPr lang="en-GB" sz="1100" dirty="0"/>
                <a:t>omega-3 PUFAs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4CB8194E-F59F-41D5-CDE1-F9B429FA6911}"/>
                </a:ext>
              </a:extLst>
            </p:cNvPr>
            <p:cNvCxnSpPr>
              <a:cxnSpLocks/>
            </p:cNvCxnSpPr>
            <p:nvPr/>
          </p:nvCxnSpPr>
          <p:spPr>
            <a:xfrm>
              <a:off x="160019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DBCB789A-FE7B-03BD-6FDB-5BBCEC019CB0}"/>
                </a:ext>
              </a:extLst>
            </p:cNvPr>
            <p:cNvCxnSpPr>
              <a:cxnSpLocks/>
            </p:cNvCxnSpPr>
            <p:nvPr/>
          </p:nvCxnSpPr>
          <p:spPr>
            <a:xfrm>
              <a:off x="2505075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7AE21B9D-F3C1-DF30-D0BF-E7F8DD3CEBF2}"/>
                </a:ext>
              </a:extLst>
            </p:cNvPr>
            <p:cNvCxnSpPr>
              <a:cxnSpLocks/>
            </p:cNvCxnSpPr>
            <p:nvPr/>
          </p:nvCxnSpPr>
          <p:spPr>
            <a:xfrm>
              <a:off x="3415868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DAB874BF-4DEC-A905-0F50-AF91F30C78B0}"/>
                </a:ext>
              </a:extLst>
            </p:cNvPr>
            <p:cNvCxnSpPr>
              <a:cxnSpLocks/>
            </p:cNvCxnSpPr>
            <p:nvPr/>
          </p:nvCxnSpPr>
          <p:spPr>
            <a:xfrm>
              <a:off x="4302149" y="2214563"/>
              <a:ext cx="8763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117A03B5-62B9-41CF-BB2E-7DDFC02DF1E7}"/>
              </a:ext>
            </a:extLst>
          </p:cNvPr>
          <p:cNvSpPr txBox="1"/>
          <p:nvPr/>
        </p:nvSpPr>
        <p:spPr>
          <a:xfrm>
            <a:off x="3029337" y="2497475"/>
            <a:ext cx="341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2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C4BAB9C-BD7F-99F8-729E-35AFEDD3EEE8}"/>
              </a:ext>
            </a:extLst>
          </p:cNvPr>
          <p:cNvSpPr/>
          <p:nvPr/>
        </p:nvSpPr>
        <p:spPr>
          <a:xfrm>
            <a:off x="3067793" y="3992625"/>
            <a:ext cx="26492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07889CE-94CF-D74B-3A81-CD638AAD6B59}"/>
              </a:ext>
            </a:extLst>
          </p:cNvPr>
          <p:cNvSpPr txBox="1"/>
          <p:nvPr/>
        </p:nvSpPr>
        <p:spPr>
          <a:xfrm>
            <a:off x="3029337" y="4068275"/>
            <a:ext cx="341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3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A0B30B6F-F4D8-231A-004B-51A19EA8212B}"/>
              </a:ext>
            </a:extLst>
          </p:cNvPr>
          <p:cNvGrpSpPr/>
          <p:nvPr/>
        </p:nvGrpSpPr>
        <p:grpSpPr>
          <a:xfrm>
            <a:off x="6943939" y="2204795"/>
            <a:ext cx="3685644" cy="440453"/>
            <a:chOff x="6943939" y="2204795"/>
            <a:chExt cx="3685644" cy="440453"/>
          </a:xfrm>
        </p:grpSpPr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2E88BED0-6D8E-5508-8724-FB8EB5E014AB}"/>
                </a:ext>
              </a:extLst>
            </p:cNvPr>
            <p:cNvSpPr/>
            <p:nvPr/>
          </p:nvSpPr>
          <p:spPr>
            <a:xfrm>
              <a:off x="6943939" y="2232757"/>
              <a:ext cx="3685644" cy="2263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2E59A12-0AAB-C3B6-4E46-3FD03824EC14}"/>
                </a:ext>
              </a:extLst>
            </p:cNvPr>
            <p:cNvSpPr txBox="1"/>
            <p:nvPr/>
          </p:nvSpPr>
          <p:spPr>
            <a:xfrm>
              <a:off x="6987207" y="2213402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ontrol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718C39A-D0D8-A7F1-8D7D-C67C53E75853}"/>
                </a:ext>
              </a:extLst>
            </p:cNvPr>
            <p:cNvSpPr txBox="1"/>
            <p:nvPr/>
          </p:nvSpPr>
          <p:spPr>
            <a:xfrm>
              <a:off x="8254499" y="2204795"/>
              <a:ext cx="1128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omega-3 PUFAs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DF0F4C3-4832-4694-B304-F01B500F0228}"/>
                </a:ext>
              </a:extLst>
            </p:cNvPr>
            <p:cNvSpPr txBox="1"/>
            <p:nvPr/>
          </p:nvSpPr>
          <p:spPr>
            <a:xfrm>
              <a:off x="7749687" y="2215239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13312FA-BAAD-B467-B4CB-A3A29CA8C860}"/>
                </a:ext>
              </a:extLst>
            </p:cNvPr>
            <p:cNvSpPr txBox="1"/>
            <p:nvPr/>
          </p:nvSpPr>
          <p:spPr>
            <a:xfrm>
              <a:off x="9015037" y="2214361"/>
              <a:ext cx="11283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 +</a:t>
              </a:r>
            </a:p>
            <a:p>
              <a:pPr algn="ctr"/>
              <a:r>
                <a:rPr lang="en-GB" sz="1100" dirty="0"/>
                <a:t>omega-3 PUFAs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33095663-479D-63AD-CEDB-CC956C344C22}"/>
                </a:ext>
              </a:extLst>
            </p:cNvPr>
            <p:cNvCxnSpPr>
              <a:cxnSpLocks/>
            </p:cNvCxnSpPr>
            <p:nvPr/>
          </p:nvCxnSpPr>
          <p:spPr>
            <a:xfrm>
              <a:off x="6943939" y="2266095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9ACF4978-0A6C-CC87-AADD-36BB47C2819B}"/>
                </a:ext>
              </a:extLst>
            </p:cNvPr>
            <p:cNvCxnSpPr>
              <a:cxnSpLocks/>
            </p:cNvCxnSpPr>
            <p:nvPr/>
          </p:nvCxnSpPr>
          <p:spPr>
            <a:xfrm>
              <a:off x="7706419" y="2265240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48F36D2A-4181-A45C-A0F7-59F31817D9DE}"/>
                </a:ext>
              </a:extLst>
            </p:cNvPr>
            <p:cNvCxnSpPr>
              <a:cxnSpLocks/>
            </p:cNvCxnSpPr>
            <p:nvPr/>
          </p:nvCxnSpPr>
          <p:spPr>
            <a:xfrm>
              <a:off x="8459209" y="2266243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03912C5D-37D4-B4F4-2949-C0C5662C1BB4}"/>
                </a:ext>
              </a:extLst>
            </p:cNvPr>
            <p:cNvCxnSpPr>
              <a:cxnSpLocks/>
            </p:cNvCxnSpPr>
            <p:nvPr/>
          </p:nvCxnSpPr>
          <p:spPr>
            <a:xfrm>
              <a:off x="9219747" y="2265240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29AA7F55-8271-5CA0-E37C-C56FB85E5E9D}"/>
              </a:ext>
            </a:extLst>
          </p:cNvPr>
          <p:cNvGrpSpPr/>
          <p:nvPr/>
        </p:nvGrpSpPr>
        <p:grpSpPr>
          <a:xfrm>
            <a:off x="6940981" y="3766321"/>
            <a:ext cx="3685644" cy="440453"/>
            <a:chOff x="6943939" y="2204795"/>
            <a:chExt cx="3685644" cy="440453"/>
          </a:xfrm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784E8843-25F6-88E8-68EC-8DEB3337C9D2}"/>
                </a:ext>
              </a:extLst>
            </p:cNvPr>
            <p:cNvSpPr/>
            <p:nvPr/>
          </p:nvSpPr>
          <p:spPr>
            <a:xfrm>
              <a:off x="6943939" y="2232757"/>
              <a:ext cx="3685644" cy="2263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6C69A5F-23E0-251E-4975-5B218E6544C1}"/>
                </a:ext>
              </a:extLst>
            </p:cNvPr>
            <p:cNvSpPr txBox="1"/>
            <p:nvPr/>
          </p:nvSpPr>
          <p:spPr>
            <a:xfrm>
              <a:off x="6987207" y="2213402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ontrol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0381E33-10F6-69AC-EBA3-A06E473BC8D5}"/>
                </a:ext>
              </a:extLst>
            </p:cNvPr>
            <p:cNvSpPr txBox="1"/>
            <p:nvPr/>
          </p:nvSpPr>
          <p:spPr>
            <a:xfrm>
              <a:off x="8254499" y="2204795"/>
              <a:ext cx="1128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omega-3 PUFAs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F1A6CEBB-FF25-47B5-5D48-06505081836D}"/>
                </a:ext>
              </a:extLst>
            </p:cNvPr>
            <p:cNvSpPr txBox="1"/>
            <p:nvPr/>
          </p:nvSpPr>
          <p:spPr>
            <a:xfrm>
              <a:off x="7749687" y="2215239"/>
              <a:ext cx="6323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DA99A3A-2525-FF58-0FC5-3FCE9EE2B3C0}"/>
                </a:ext>
              </a:extLst>
            </p:cNvPr>
            <p:cNvSpPr txBox="1"/>
            <p:nvPr/>
          </p:nvSpPr>
          <p:spPr>
            <a:xfrm>
              <a:off x="9015037" y="2214361"/>
              <a:ext cx="11283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ulin +</a:t>
              </a:r>
            </a:p>
            <a:p>
              <a:pPr algn="ctr"/>
              <a:r>
                <a:rPr lang="en-GB" sz="1100" dirty="0"/>
                <a:t>omega-3 PUFAs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B7BD12DF-AC24-1F69-31BE-056E91CCFF34}"/>
                </a:ext>
              </a:extLst>
            </p:cNvPr>
            <p:cNvCxnSpPr>
              <a:cxnSpLocks/>
            </p:cNvCxnSpPr>
            <p:nvPr/>
          </p:nvCxnSpPr>
          <p:spPr>
            <a:xfrm>
              <a:off x="6943939" y="2266095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AFDF8B53-6FE9-3CEE-E007-ECDABD86CD80}"/>
                </a:ext>
              </a:extLst>
            </p:cNvPr>
            <p:cNvCxnSpPr>
              <a:cxnSpLocks/>
            </p:cNvCxnSpPr>
            <p:nvPr/>
          </p:nvCxnSpPr>
          <p:spPr>
            <a:xfrm>
              <a:off x="7706419" y="2265240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B0DF6BFB-3372-9264-A4B7-B653BC0F3100}"/>
                </a:ext>
              </a:extLst>
            </p:cNvPr>
            <p:cNvCxnSpPr>
              <a:cxnSpLocks/>
            </p:cNvCxnSpPr>
            <p:nvPr/>
          </p:nvCxnSpPr>
          <p:spPr>
            <a:xfrm>
              <a:off x="8459209" y="2266243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0421250A-E9EF-098F-8A42-5A50A0574120}"/>
                </a:ext>
              </a:extLst>
            </p:cNvPr>
            <p:cNvCxnSpPr>
              <a:cxnSpLocks/>
            </p:cNvCxnSpPr>
            <p:nvPr/>
          </p:nvCxnSpPr>
          <p:spPr>
            <a:xfrm>
              <a:off x="9219747" y="2265240"/>
              <a:ext cx="718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07379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2d6fbf6b-86a0-4221-b338-fa011265aad5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2039574AD2D4D41A112C7A1475113D9" ma:contentTypeVersion="10" ma:contentTypeDescription="Create a new document." ma:contentTypeScope="" ma:versionID="ca0706331b2bd4ced431884902e5cc9c">
  <xsd:schema xmlns:xsd="http://www.w3.org/2001/XMLSchema" xmlns:xs="http://www.w3.org/2001/XMLSchema" xmlns:p="http://schemas.microsoft.com/office/2006/metadata/properties" xmlns:ns3="2d6fbf6b-86a0-4221-b338-fa011265aad5" xmlns:ns4="430cf7ca-d03a-48f8-a175-d638fbb9f30d" targetNamespace="http://schemas.microsoft.com/office/2006/metadata/properties" ma:root="true" ma:fieldsID="697fac7e8b8de0bd4848549ccd1efbb3" ns3:_="" ns4:_="">
    <xsd:import namespace="2d6fbf6b-86a0-4221-b338-fa011265aad5"/>
    <xsd:import namespace="430cf7ca-d03a-48f8-a175-d638fbb9f30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SearchProperties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d6fbf6b-86a0-4221-b338-fa011265aad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5" nillable="true" ma:displayName="_activity" ma:hidden="true" ma:internalName="_activity">
      <xsd:simpleType>
        <xsd:restriction base="dms:Note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0cf7ca-d03a-48f8-a175-d638fbb9f30d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717F3F9-98E5-4DF2-A2D4-ABAD2A83698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1E52071-BA9E-4319-BB98-C1823F3CA9D2}">
  <ds:schemaRefs>
    <ds:schemaRef ds:uri="http://purl.org/dc/elements/1.1/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2d6fbf6b-86a0-4221-b338-fa011265aad5"/>
    <ds:schemaRef ds:uri="http://purl.org/dc/dcmitype/"/>
    <ds:schemaRef ds:uri="http://schemas.microsoft.com/office/infopath/2007/PartnerControls"/>
    <ds:schemaRef ds:uri="430cf7ca-d03a-48f8-a175-d638fbb9f30d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DDD3F85-F156-4576-8248-3C6747B353A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d6fbf6b-86a0-4221-b338-fa011265aad5"/>
    <ds:schemaRef ds:uri="430cf7ca-d03a-48f8-a175-d638fbb9f30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53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5</cp:revision>
  <dcterms:created xsi:type="dcterms:W3CDTF">2024-10-07T15:56:39Z</dcterms:created>
  <dcterms:modified xsi:type="dcterms:W3CDTF">2025-01-13T08:2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2039574AD2D4D41A112C7A1475113D9</vt:lpwstr>
  </property>
</Properties>
</file>